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641" r:id="rId2"/>
    <p:sldId id="644" r:id="rId3"/>
    <p:sldId id="642" r:id="rId4"/>
    <p:sldId id="64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9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49F09C-73DB-4375-8797-AEE019BF341F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5523D1-4F01-47AC-A428-5832357C90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6914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otnotes: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rticipants who were identified to have </a:t>
            </a:r>
            <a:r>
              <a:rPr lang="en-US" sz="1800" dirty="0">
                <a:solidFill>
                  <a:srgbClr val="0D0D0D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derate or severely immunocompromising condition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n=20) were: 1, 6, 7, 8, 10, 11, 12, 13, 17, 20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22, 24, 25, 26, 28, 31, 32, 35, 36, 37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D0D0D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moderate or severely immunocompromising condition included the following: recent or active malignancy, bone marrow transplant, solid organ transplant, primary or secondary immune deficiency, or the use of oral or intravenous steroids for more than a month or any immunosuppressant drugs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sz="1800" dirty="0"/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is graph shows the titers of measured anti-S IgG antibodies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eropositivity thresholds were defined by the manufacturer and listed in the kit insert as follows: anti-S IgG 17.66 BAU/mL (lowermost dashed line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alibration of the SARS-CoV-2 antibody assays to the 1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WHO international standard for anti-SARS-CoV-2 Ig allowed us to visually assess antibody concentrations in our evaluation to those associated with a computed average overall protective threshold of 154 BAU/mL for wild type, 95% Pfizer BNT162b2 VE against COVID-19 (for two doses against wild type 530 anti-S IgG BAU/mL; Goldblatt, 2022) and 90% Moderna mRNA-1273 VE against COVID-19 (for two dose against wild type, 298 anti-S IgG BAU/mL and 775 anti-RBD IgG BAU/mL; Gilbert, 2022) — as indicated by the three upper dashed lines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4FAECA-2E45-4C9E-BFA9-9C80625290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9654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otnote: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is graph shows the titers of measured anti-RBD IgG antibodies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eropositivity thresholds were defined by the manufacturer and listed in the kit insert as follows: anti-RBD IgG 14.64 BAU/mL as indicated by the lower dashed line. Calibration of the SARS-CoV-2 antibody assays to the WHO 1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t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international standard for anti-SARS-CoV-2 immunoglobulin allowed us to compare antibody concentrations in our evaluation to those associated with 90% Moderna mRNA-1273 VE against COVID-19 (775 anti-RBD IgG BAU/mL — as indicated by the upper dashed line; Gilbert, 2022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4FAECA-2E45-4C9E-BFA9-9C80625290D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5895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otnote: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is graph shows the titers of measured anti-N IgG antibodies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4FAECA-2E45-4C9E-BFA9-9C80625290D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9157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otnote: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Virus neutralizing capacity = percent spike inhibition; Y axis in %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4FAECA-2E45-4C9E-BFA9-9C80625290D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7925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954B9F-4AB4-8A05-80A5-49734B0535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75D4C16-79CE-DD4F-65D4-025E9161D9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292C60-5D90-F2B5-2347-06E509158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1CADDE-F161-B263-45AE-9D7252D086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F673F7-319A-EEAA-75BC-DC51FF6C3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295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FD54E8-ABD8-5D42-678E-E3884F2D45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D78CDA-B615-8E42-5D4C-D0096F1D2A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53C2B3-374C-16A6-6747-16F3263DC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A581B6-34FA-2777-9713-C0B06440C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2A9D1F-BFAC-BE42-84D9-2AC2173558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417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9B1085-6790-9B1C-3849-01B028634E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A776C8-A05D-2847-5C8E-B5583E6B05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4AAB52-396D-2490-6871-BAFE075DA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B5EBC7-B18A-A478-41AB-58927371F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4CC34F-480E-F88F-1EC2-1D37CB6F5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009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2A57CC-6BCF-A784-E653-7073A649E7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C71F0B-6FE4-3108-DE0C-BDEEAF748F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573184-4525-83D5-EEBA-F31058064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72D6B2-A046-921D-6C9A-D0EDE6851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3685E2-9228-BD46-638C-5CB9F1400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28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1107EC-7BED-0BF2-82C0-F28C27D9F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BE0EE4-CECC-9B60-A560-64A3B828BD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B57985-92C7-4E22-8EBB-B7402D1B5C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221FDB-00FA-83FA-E57C-F9C94C768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171DDB-0F29-9A94-0AEE-26113BAE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524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B3E837-B3E6-CDD4-5D0C-9AC2FA843E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06EA05-1EA0-A6A9-7A06-EE66838422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17AE5C-7AEE-DD4F-1D8F-FF1B05150C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28AE2A-8681-8F20-1C31-2A7247D47D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E1B7F9-9687-A119-D34A-4BB3BF7071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3804C5-7C46-7883-5CB8-5DDB3A99D8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592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19B0B3-D7C7-BD7C-4C3C-20929A38EB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AB4133-7911-2008-61E3-6D92409A3C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F4AA89-C00D-3F7C-761D-1BCD8FB1FE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D198B0-76F1-E599-9C39-FDC55F872D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66A592-A683-D4B8-68F6-3B818FF617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6D3EA9F-31DB-193F-ED29-7DC47DAF0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199464C-8B42-1158-3649-A7AB8CE2B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565128-453C-84B0-176F-6F3B43477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432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9A4231-41A7-A284-0F3A-0F10F698B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C79295-CD50-D091-D323-6FAE8869D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655072-AB8C-4BB1-6B69-6892D77D1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F13FA01-2940-3498-6B94-E2C0A1EDC8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4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236DF4-D7A9-564E-1731-A88300EA88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8D8ADC3-0AF0-6214-628E-867BA9918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C59CAA-CCAF-A4B9-009C-3A4A665C3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593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24EB0F-CEF6-A99C-E157-72826743D7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4FD93C-C1FB-245C-2C02-0C588BE65E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6D2CF8-4CE0-2433-BC84-81F22F694E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B9B95F-9752-B868-B13C-43F299459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B8D5F1-FD7E-DF08-1705-B9153CF81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20A12D-CBE2-D674-0693-3025C3E0F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56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1A116-A2FE-E0A8-4743-F334184E05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070E69B-A10D-0E57-F776-FF402B2140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03B437-6BE1-1CEC-3FC3-C614565793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BDFC5C-CF65-1CE9-6B4A-CBBD06991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732CE6-567F-4569-94D2-42A15E1AEA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7071C7-0EF8-0242-D6DE-AF9F14961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805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6DDAB6-DB89-418F-78E3-4D9BE3495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895C9C-3AD9-F514-A5B2-ADFE6E569E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87E602-C9A2-DB21-0036-9B962B49701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B187E-1409-42B8-A6B5-158B6FBA8635}" type="datetimeFigureOut">
              <a:rPr lang="en-US" smtClean="0"/>
              <a:t>3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1DD8EB-4654-B816-5A07-1CE4A03FA1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1C1A8D-C688-35AF-ED9A-FFB1F36FF1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BCFEB5-64F5-4DA4-8D41-3B8970739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767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CF4698-1EEC-86D1-B959-55C2C3E073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Bef>
                <a:spcPts val="0"/>
              </a:spcBef>
              <a:spcAft>
                <a:spcPts val="667"/>
              </a:spcAft>
            </a:pP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Calibri"/>
                <a:cs typeface="Calibri"/>
              </a:rPr>
              <a:t>Figure S2: Longitudinal antibody responses for each participant in the nursing home cohort (N=37) — Georgia, December 2020–July 2022</a:t>
            </a:r>
            <a:b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Calibri"/>
                <a:cs typeface="Calibri"/>
              </a:rPr>
            </a:b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Calibri"/>
                <a:cs typeface="Calibri"/>
              </a:rPr>
              <a:t>Figure S2A: Anti-SARS-CoV-2 Spike (S) IgG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112C7A1-4FFA-D183-5A20-6820D82DC79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152" y="1778664"/>
            <a:ext cx="11430000" cy="41439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11401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alendar&#10;&#10;Description automatically generated">
            <a:extLst>
              <a:ext uri="{FF2B5EF4-FFF2-40B4-BE49-F238E27FC236}">
                <a16:creationId xmlns:a16="http://schemas.microsoft.com/office/drawing/2014/main" id="{88A656C9-E139-08B6-D411-901C82CCD9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271" y="1392114"/>
            <a:ext cx="11430000" cy="494218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5528BC0-DB81-9AC4-EAFF-15A5C11E6BA9}"/>
              </a:ext>
            </a:extLst>
          </p:cNvPr>
          <p:cNvSpPr txBox="1"/>
          <p:nvPr/>
        </p:nvSpPr>
        <p:spPr>
          <a:xfrm>
            <a:off x="665080" y="749201"/>
            <a:ext cx="1086765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: Longitudinal antibody responses for each participant in the nursing home cohort (N=37) — Georgia, December 2020–July 2022</a:t>
            </a:r>
            <a:b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B: Anti-SARS-CoV-2 Receptor Binding Domain (RBD) IgG </a:t>
            </a:r>
            <a:endParaRPr lang="en-US" sz="1500" dirty="0">
              <a:solidFill>
                <a:schemeClr val="tx1">
                  <a:lumMod val="95000"/>
                  <a:lumOff val="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84057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2B2F4-8874-F883-6795-BB68365878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>
              <a:lnSpc>
                <a:spcPct val="107000"/>
              </a:lnSpc>
              <a:spcBef>
                <a:spcPts val="0"/>
              </a:spcBef>
              <a:spcAft>
                <a:spcPts val="667"/>
              </a:spcAft>
            </a:pP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C: Anti-SARS-CoV-2 Nucleocapsid IgG for those with hybrid immunit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ABDDB99-6219-1CBF-1729-D7F5BB9C6B9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499" y="1403862"/>
            <a:ext cx="11430000" cy="50890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74089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FBA6B9-0977-0FB3-923A-401F11F187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>
              <a:lnSpc>
                <a:spcPct val="107000"/>
              </a:lnSpc>
              <a:spcBef>
                <a:spcPts val="0"/>
              </a:spcBef>
              <a:spcAft>
                <a:spcPts val="667"/>
              </a:spcAft>
            </a:pPr>
            <a:r>
              <a:rPr lang="en-US" sz="1500" dirty="0">
                <a:solidFill>
                  <a:schemeClr val="tx1">
                    <a:lumMod val="95000"/>
                    <a:lumOff val="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2D: Percent Spike Inhibition (virus neutralization capacity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B81CBB7-7242-C863-2C9D-ADD0B8052A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000" y="1690688"/>
            <a:ext cx="11430000" cy="4501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82815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83</Words>
  <Application>Microsoft Office PowerPoint</Application>
  <PresentationFormat>Widescreen</PresentationFormat>
  <Paragraphs>22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Figure S2: Longitudinal antibody responses for each participant in the nursing home cohort (N=37) — Georgia, December 2020–July 2022 Figure S2A: Anti-SARS-CoV-2 Spike (S) IgG </vt:lpstr>
      <vt:lpstr>PowerPoint Presentation</vt:lpstr>
      <vt:lpstr>Figure S2C: Anti-SARS-CoV-2 Nucleocapsid IgG for those with hybrid immunity</vt:lpstr>
      <vt:lpstr>Figure S2D: Percent Spike Inhibition (virus neutralization capacity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2: Longitudinal antibody responses for each participant in the nursing home cohort (N=37) — Georgia, December 2020–July 2022 Figure S2A: Anti-SARS-CoV-2 Spike (S) IgG </dc:title>
  <dc:creator>Chisty, Zeshan (CDC/NCEZID/DHQP/HSSRTB)</dc:creator>
  <cp:lastModifiedBy>Chisty, Zeshan (CDC/NCEZID/DHQP/HSSRTB)</cp:lastModifiedBy>
  <cp:revision>1</cp:revision>
  <dcterms:created xsi:type="dcterms:W3CDTF">2024-03-25T16:08:52Z</dcterms:created>
  <dcterms:modified xsi:type="dcterms:W3CDTF">2024-03-25T16:10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b94a7b8-f06c-4dfe-bdcc-9b548fd58c31_Enabled">
    <vt:lpwstr>true</vt:lpwstr>
  </property>
  <property fmtid="{D5CDD505-2E9C-101B-9397-08002B2CF9AE}" pid="3" name="MSIP_Label_7b94a7b8-f06c-4dfe-bdcc-9b548fd58c31_SetDate">
    <vt:lpwstr>2024-03-25T16:10:46Z</vt:lpwstr>
  </property>
  <property fmtid="{D5CDD505-2E9C-101B-9397-08002B2CF9AE}" pid="4" name="MSIP_Label_7b94a7b8-f06c-4dfe-bdcc-9b548fd58c31_Method">
    <vt:lpwstr>Privileged</vt:lpwstr>
  </property>
  <property fmtid="{D5CDD505-2E9C-101B-9397-08002B2CF9AE}" pid="5" name="MSIP_Label_7b94a7b8-f06c-4dfe-bdcc-9b548fd58c31_Name">
    <vt:lpwstr>7b94a7b8-f06c-4dfe-bdcc-9b548fd58c31</vt:lpwstr>
  </property>
  <property fmtid="{D5CDD505-2E9C-101B-9397-08002B2CF9AE}" pid="6" name="MSIP_Label_7b94a7b8-f06c-4dfe-bdcc-9b548fd58c31_SiteId">
    <vt:lpwstr>9ce70869-60db-44fd-abe8-d2767077fc8f</vt:lpwstr>
  </property>
  <property fmtid="{D5CDD505-2E9C-101B-9397-08002B2CF9AE}" pid="7" name="MSIP_Label_7b94a7b8-f06c-4dfe-bdcc-9b548fd58c31_ActionId">
    <vt:lpwstr>72083849-66bc-4ea9-af4f-9a636f03fed8</vt:lpwstr>
  </property>
  <property fmtid="{D5CDD505-2E9C-101B-9397-08002B2CF9AE}" pid="8" name="MSIP_Label_7b94a7b8-f06c-4dfe-bdcc-9b548fd58c31_ContentBits">
    <vt:lpwstr>0</vt:lpwstr>
  </property>
</Properties>
</file>